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3300" y="-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62CC3-DB2C-4C4D-A165-785653133543}" type="datetimeFigureOut">
              <a:rPr lang="fr-FR" smtClean="0"/>
              <a:t>23/10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FD955-CCCE-488C-8B18-472F543B3C2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375592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62CC3-DB2C-4C4D-A165-785653133543}" type="datetimeFigureOut">
              <a:rPr lang="fr-FR" smtClean="0"/>
              <a:t>23/10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FD955-CCCE-488C-8B18-472F543B3C2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273537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62CC3-DB2C-4C4D-A165-785653133543}" type="datetimeFigureOut">
              <a:rPr lang="fr-FR" smtClean="0"/>
              <a:t>23/10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FD955-CCCE-488C-8B18-472F543B3C2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9524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62CC3-DB2C-4C4D-A165-785653133543}" type="datetimeFigureOut">
              <a:rPr lang="fr-FR" smtClean="0"/>
              <a:t>23/10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FD955-CCCE-488C-8B18-472F543B3C2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318039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62CC3-DB2C-4C4D-A165-785653133543}" type="datetimeFigureOut">
              <a:rPr lang="fr-FR" smtClean="0"/>
              <a:t>23/10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FD955-CCCE-488C-8B18-472F543B3C2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23078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62CC3-DB2C-4C4D-A165-785653133543}" type="datetimeFigureOut">
              <a:rPr lang="fr-FR" smtClean="0"/>
              <a:t>23/10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FD955-CCCE-488C-8B18-472F543B3C2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195541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62CC3-DB2C-4C4D-A165-785653133543}" type="datetimeFigureOut">
              <a:rPr lang="fr-FR" smtClean="0"/>
              <a:t>23/10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FD955-CCCE-488C-8B18-472F543B3C2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469558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62CC3-DB2C-4C4D-A165-785653133543}" type="datetimeFigureOut">
              <a:rPr lang="fr-FR" smtClean="0"/>
              <a:t>23/10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FD955-CCCE-488C-8B18-472F543B3C2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97779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62CC3-DB2C-4C4D-A165-785653133543}" type="datetimeFigureOut">
              <a:rPr lang="fr-FR" smtClean="0"/>
              <a:t>23/10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FD955-CCCE-488C-8B18-472F543B3C2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62326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62CC3-DB2C-4C4D-A165-785653133543}" type="datetimeFigureOut">
              <a:rPr lang="fr-FR" smtClean="0"/>
              <a:t>23/10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FD955-CCCE-488C-8B18-472F543B3C2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55712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62CC3-DB2C-4C4D-A165-785653133543}" type="datetimeFigureOut">
              <a:rPr lang="fr-FR" smtClean="0"/>
              <a:t>23/10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FD955-CCCE-488C-8B18-472F543B3C2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703745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362CC3-DB2C-4C4D-A165-785653133543}" type="datetimeFigureOut">
              <a:rPr lang="fr-FR" smtClean="0"/>
              <a:t>23/10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EFD955-CCCE-488C-8B18-472F543B3C2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288341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2736" y="827584"/>
            <a:ext cx="4486128" cy="3528392"/>
          </a:xfrm>
          <a:prstGeom prst="rect">
            <a:avLst/>
          </a:prstGeom>
        </p:spPr>
      </p:pic>
      <p:sp>
        <p:nvSpPr>
          <p:cNvPr id="2" name="ZoneTexte 1"/>
          <p:cNvSpPr txBox="1"/>
          <p:nvPr/>
        </p:nvSpPr>
        <p:spPr>
          <a:xfrm>
            <a:off x="908720" y="4719892"/>
            <a:ext cx="5400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latin typeface="Palatino Linotype" pitchFamily="18" charset="0"/>
              </a:rPr>
              <a:t>Figure </a:t>
            </a:r>
            <a:r>
              <a:rPr lang="en-US" sz="900" b="1" dirty="0" smtClean="0">
                <a:latin typeface="Palatino Linotype" pitchFamily="18" charset="0"/>
              </a:rPr>
              <a:t>Supplemental </a:t>
            </a:r>
            <a:r>
              <a:rPr lang="en-US" sz="900" b="1" dirty="0" smtClean="0">
                <a:latin typeface="Palatino Linotype" pitchFamily="18" charset="0"/>
              </a:rPr>
              <a:t>1: </a:t>
            </a:r>
            <a:r>
              <a:rPr lang="en-US" sz="900" b="1" dirty="0">
                <a:latin typeface="Palatino Linotype" pitchFamily="18" charset="0"/>
              </a:rPr>
              <a:t>Overall survival (OS) curves according to the four stages of IE of DLBCL patients from public microarrays data (n=200) (log rank </a:t>
            </a:r>
            <a:r>
              <a:rPr lang="en-US" sz="900" b="1" i="1" dirty="0">
                <a:latin typeface="Palatino Linotype" pitchFamily="18" charset="0"/>
              </a:rPr>
              <a:t>p=0,0006</a:t>
            </a:r>
            <a:r>
              <a:rPr lang="en-US" sz="900" b="1" dirty="0">
                <a:latin typeface="Palatino Linotype" pitchFamily="18" charset="0"/>
              </a:rPr>
              <a:t>)</a:t>
            </a:r>
            <a:endParaRPr lang="fr-FR" sz="900" b="1" dirty="0">
              <a:latin typeface="Palatino Linotype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171007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2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emp</dc:creator>
  <cp:lastModifiedBy>temp</cp:lastModifiedBy>
  <cp:revision>3</cp:revision>
  <dcterms:created xsi:type="dcterms:W3CDTF">2018-09-17T09:46:33Z</dcterms:created>
  <dcterms:modified xsi:type="dcterms:W3CDTF">2018-10-23T12:08:18Z</dcterms:modified>
</cp:coreProperties>
</file>